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9.xml.rels" ContentType="application/vnd.openxmlformats-package.relationships+xml"/>
  <Override PartName="/ppt/notesSlides/_rels/notesSlide13.xml.rels" ContentType="application/vnd.openxmlformats-package.relationships+xml"/>
  <Override PartName="/ppt/notesSlides/_rels/notesSlide6.xml.rels" ContentType="application/vnd.openxmlformats-package.relationships+xml"/>
  <Override PartName="/ppt/notesSlides/_rels/notesSlide8.xml.rels" ContentType="application/vnd.openxmlformats-package.relationships+xml"/>
  <Override PartName="/ppt/notesSlides/_rels/notesSlide2.xml.rels" ContentType="application/vnd.openxmlformats-package.relationships+xml"/>
  <Override PartName="/ppt/notesSlides/_rels/notesSlide7.xml.rels" ContentType="application/vnd.openxmlformats-package.relationships+xml"/>
  <Override PartName="/ppt/notesSlides/_rels/notesSlide1.xml.rels" ContentType="application/vnd.openxmlformats-package.relationships+xml"/>
  <Override PartName="/ppt/notesSlides/_rels/notesSlide12.xml.rels" ContentType="application/vnd.openxmlformats-package.relationships+xml"/>
  <Override PartName="/ppt/notesSlides/_rels/notesSlide5.xml.rels" ContentType="application/vnd.openxmlformats-package.relationships+xml"/>
  <Override PartName="/ppt/notesSlides/_rels/notesSlide11.xml.rels" ContentType="application/vnd.openxmlformats-package.relationships+xml"/>
  <Override PartName="/ppt/notesSlides/_rels/notesSlide4.xml.rels" ContentType="application/vnd.openxmlformats-package.relationships+xml"/>
  <Override PartName="/ppt/notesSlides/_rels/notesSlide10.xml.rels" ContentType="application/vnd.openxmlformats-package.relationships+xml"/>
  <Override PartName="/ppt/notesSlides/_rels/notesSlide3.xml.rels" ContentType="application/vnd.openxmlformats-package.relationships+xml"/>
  <Override PartName="/ppt/notesSlides/notesSlide9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936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0" y="0"/>
            <a:ext cx="6858000" cy="9144000"/>
          </a:xfrm>
          <a:custGeom>
            <a:avLst/>
            <a:gdLst>
              <a:gd name="textAreaLeft" fmla="*/ 360 w 6858000"/>
              <a:gd name="textAreaRight" fmla="*/ 6857640 w 6858000"/>
              <a:gd name="textAreaTop" fmla="*/ 360 h 9144000"/>
              <a:gd name="textAreaBottom" fmla="*/ 9143640 h 9144000"/>
            </a:gdLst>
            <a:ahLst/>
            <a:rect l="textAreaLeft" t="textAreaTop" r="textAreaRight" b="textAreaBottom"/>
            <a:pathLst>
              <a:path w="21600" h="28800">
                <a:moveTo>
                  <a:pt x="5" y="0"/>
                </a:moveTo>
                <a:arcTo wR="5" hR="5" stAng="16200000" swAng="-5400000"/>
                <a:lnTo>
                  <a:pt x="0" y="28795"/>
                </a:lnTo>
                <a:arcTo wR="5" hR="5" stAng="10800000" swAng="-5400000"/>
                <a:lnTo>
                  <a:pt x="21595" y="28800"/>
                </a:lnTo>
                <a:arcTo wR="5" hR="5" stAng="5400000" swAng="-5400000"/>
                <a:lnTo>
                  <a:pt x="21600" y="5"/>
                </a:lnTo>
                <a:arcTo wR="5" hR="5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0360" cy="455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2"/>
          <p:cNvSpPr>
            <a:spLocks noGrp="1"/>
          </p:cNvSpPr>
          <p:nvPr>
            <p:ph type="dt" idx="4"/>
          </p:nvPr>
        </p:nvSpPr>
        <p:spPr>
          <a:xfrm>
            <a:off x="3884760" y="0"/>
            <a:ext cx="2970000" cy="455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0560" cy="34275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4960" cy="4113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PlaceHolder 5"/>
          <p:cNvSpPr>
            <a:spLocks noGrp="1"/>
          </p:cNvSpPr>
          <p:nvPr>
            <p:ph type="ftr" idx="5"/>
          </p:nvPr>
        </p:nvSpPr>
        <p:spPr>
          <a:xfrm>
            <a:off x="-360" y="8685000"/>
            <a:ext cx="2970360" cy="45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laceHolder 6"/>
          <p:cNvSpPr>
            <a:spLocks noGrp="1"/>
          </p:cNvSpPr>
          <p:nvPr>
            <p:ph type="sldNum" idx="6"/>
          </p:nvPr>
        </p:nvSpPr>
        <p:spPr>
          <a:xfrm>
            <a:off x="3884760" y="8685000"/>
            <a:ext cx="2970000" cy="45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8B3EB886-CA34-4B14-8C35-91A02A9655C6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10.xml.rels><?xml version="1.0" encoding="UTF-8"?>
<Relationships xmlns="http://schemas.openxmlformats.org/package/2006/relationships"><Relationship Id="rId1" Type="http://schemas.openxmlformats.org/officeDocument/2006/relationships/slide" Target="../slides/slide10.xml"/><Relationship Id="rId2" Type="http://schemas.openxmlformats.org/officeDocument/2006/relationships/notesMaster" Target="../notesMasters/notesMaster1.xml"/>
</Relationships>
</file>

<file path=ppt/notesSlides/_rels/notesSlide11.xml.rels><?xml version="1.0" encoding="UTF-8"?>
<Relationships xmlns="http://schemas.openxmlformats.org/package/2006/relationships"><Relationship Id="rId1" Type="http://schemas.openxmlformats.org/officeDocument/2006/relationships/slide" Target="../slides/slide11.xml"/><Relationship Id="rId2" Type="http://schemas.openxmlformats.org/officeDocument/2006/relationships/notesMaster" Target="../notesMasters/notesMaster1.xml"/>
</Relationships>
</file>

<file path=ppt/notesSlides/_rels/notesSlide12.xml.rels><?xml version="1.0" encoding="UTF-8"?>
<Relationships xmlns="http://schemas.openxmlformats.org/package/2006/relationships"><Relationship Id="rId1" Type="http://schemas.openxmlformats.org/officeDocument/2006/relationships/slide" Target="../slides/slide12.xml"/><Relationship Id="rId2" Type="http://schemas.openxmlformats.org/officeDocument/2006/relationships/notesMaster" Target="../notesMasters/notesMaster1.xml"/>
</Relationships>
</file>

<file path=ppt/notesSlides/_rels/notesSlide13.xml.rels><?xml version="1.0" encoding="UTF-8"?>
<Relationships xmlns="http://schemas.openxmlformats.org/package/2006/relationships"><Relationship Id="rId1" Type="http://schemas.openxmlformats.org/officeDocument/2006/relationships/slide" Target="../slides/slide13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_rels/notesSlide8.xml.rels><?xml version="1.0" encoding="UTF-8"?>
<Relationships xmlns="http://schemas.openxmlformats.org/package/2006/relationships"><Relationship Id="rId1" Type="http://schemas.openxmlformats.org/officeDocument/2006/relationships/slide" Target="../slides/slide8.xml"/><Relationship Id="rId2" Type="http://schemas.openxmlformats.org/officeDocument/2006/relationships/notesMaster" Target="../notesMasters/notesMaster1.xml"/>
</Relationships>
</file>

<file path=ppt/notesSlides/_rels/notesSlide9.xml.rels><?xml version="1.0" encoding="UTF-8"?>
<Relationships xmlns="http://schemas.openxmlformats.org/package/2006/relationships"><Relationship Id="rId1" Type="http://schemas.openxmlformats.org/officeDocument/2006/relationships/slide" Target="../slides/slide9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1" name=""/>
          <p:cNvSpPr/>
          <p:nvPr/>
        </p:nvSpPr>
        <p:spPr>
          <a:xfrm>
            <a:off x="1143000" y="68580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PlaceHolder 1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208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1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9" name=""/>
          <p:cNvSpPr/>
          <p:nvPr/>
        </p:nvSpPr>
        <p:spPr>
          <a:xfrm>
            <a:off x="1143000" y="68580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PlaceHolder 1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208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1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1" name=""/>
          <p:cNvSpPr/>
          <p:nvPr/>
        </p:nvSpPr>
        <p:spPr>
          <a:xfrm>
            <a:off x="1143000" y="68580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PlaceHolder 1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208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1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3" name=""/>
          <p:cNvSpPr/>
          <p:nvPr/>
        </p:nvSpPr>
        <p:spPr>
          <a:xfrm>
            <a:off x="1143000" y="68580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PlaceHolder 1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208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1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5" name=""/>
          <p:cNvSpPr/>
          <p:nvPr/>
        </p:nvSpPr>
        <p:spPr>
          <a:xfrm>
            <a:off x="1143000" y="68580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PlaceHolder 1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208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3" name=""/>
          <p:cNvSpPr/>
          <p:nvPr/>
        </p:nvSpPr>
        <p:spPr>
          <a:xfrm>
            <a:off x="1143000" y="68580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PlaceHolder 1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208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"/>
          <p:cNvSpPr/>
          <p:nvPr/>
        </p:nvSpPr>
        <p:spPr>
          <a:xfrm>
            <a:off x="1143000" y="68580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PlaceHolder 1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208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7" name=""/>
          <p:cNvSpPr/>
          <p:nvPr/>
        </p:nvSpPr>
        <p:spPr>
          <a:xfrm>
            <a:off x="1143000" y="68580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PlaceHolder 1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208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9" name=""/>
          <p:cNvSpPr/>
          <p:nvPr/>
        </p:nvSpPr>
        <p:spPr>
          <a:xfrm>
            <a:off x="1143000" y="68580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PlaceHolder 1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208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1" name=""/>
          <p:cNvSpPr/>
          <p:nvPr/>
        </p:nvSpPr>
        <p:spPr>
          <a:xfrm>
            <a:off x="1143000" y="68580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PlaceHolder 1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208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3" name=""/>
          <p:cNvSpPr/>
          <p:nvPr/>
        </p:nvSpPr>
        <p:spPr>
          <a:xfrm>
            <a:off x="1143000" y="68580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PlaceHolder 1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208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5" name=""/>
          <p:cNvSpPr/>
          <p:nvPr/>
        </p:nvSpPr>
        <p:spPr>
          <a:xfrm>
            <a:off x="1143000" y="68580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PlaceHolder 1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208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7" name=""/>
          <p:cNvSpPr/>
          <p:nvPr/>
        </p:nvSpPr>
        <p:spPr>
          <a:xfrm>
            <a:off x="1143000" y="68580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PlaceHolder 1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208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81F912-175F-42DB-8F30-955C9C00DD0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782C14-18A4-4498-9BD7-37E927E0122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E7FE4B-D9FF-4352-B1E2-E5C93E61015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28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136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28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136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F7147D-14A1-46D9-8016-CE14CFF0227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D1E1AF-A24B-4162-83A7-948CEACE9D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D5F5D5-7FA9-41E4-9BB8-4B4170F3929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7644E9-A72D-4272-A96A-5A073E8F61A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0D5219-F6C7-47EF-9838-3CA62B1D66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680"/>
            <a:ext cx="8228160" cy="529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8E208B-3114-4F2A-9ADB-F7DBB837169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F5C4AF-D58E-4396-B29C-6A4183CB03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7254C8-2ECA-4CFD-9E6D-E1178D240B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643C42-B9CB-44CA-881F-2CDE254CF7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7200" y="6245280"/>
            <a:ext cx="213192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3720" y="6245280"/>
            <a:ext cx="289404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5280"/>
            <a:ext cx="213228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BD465454-7DC1-4307-9A20-BCC493063CE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0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2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7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8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9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"/>
          <p:cNvSpPr/>
          <p:nvPr/>
        </p:nvSpPr>
        <p:spPr>
          <a:xfrm>
            <a:off x="457200" y="228600"/>
            <a:ext cx="243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97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" descr=""/>
          <p:cNvPicPr/>
          <p:nvPr/>
        </p:nvPicPr>
        <p:blipFill>
          <a:blip r:embed="rId1"/>
          <a:stretch/>
        </p:blipFill>
        <p:spPr>
          <a:xfrm>
            <a:off x="2743200" y="990720"/>
            <a:ext cx="5203800" cy="3814560"/>
          </a:xfrm>
          <a:prstGeom prst="rect">
            <a:avLst/>
          </a:prstGeom>
          <a:ln w="0">
            <a:noFill/>
          </a:ln>
        </p:spPr>
      </p:pic>
      <p:grpSp>
        <p:nvGrpSpPr>
          <p:cNvPr id="51" name=""/>
          <p:cNvGrpSpPr/>
          <p:nvPr/>
        </p:nvGrpSpPr>
        <p:grpSpPr>
          <a:xfrm>
            <a:off x="228600" y="990720"/>
            <a:ext cx="2222640" cy="1645560"/>
            <a:chOff x="228600" y="990720"/>
            <a:chExt cx="2222640" cy="1645560"/>
          </a:xfrm>
        </p:grpSpPr>
        <p:sp>
          <p:nvSpPr>
            <p:cNvPr id="52" name=""/>
            <p:cNvSpPr/>
            <p:nvPr/>
          </p:nvSpPr>
          <p:spPr>
            <a:xfrm>
              <a:off x="228600" y="1066680"/>
              <a:ext cx="136440" cy="1368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28600" y="1768320"/>
              <a:ext cx="136440" cy="1368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228600" y="2438280"/>
              <a:ext cx="136440" cy="136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228600" y="1295280"/>
              <a:ext cx="152280" cy="152640"/>
            </a:xfrm>
            <a:prstGeom prst="diamond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228600" y="1981080"/>
              <a:ext cx="152280" cy="152640"/>
            </a:xfrm>
            <a:prstGeom prst="diamond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28600" y="1523880"/>
              <a:ext cx="152280" cy="15264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" bIns="4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 flipV="1">
              <a:off x="228600" y="2209680"/>
              <a:ext cx="152280" cy="15264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" bIns="4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457200" y="9907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melanogaste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457200" y="122868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ananassa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457200" y="1447920"/>
              <a:ext cx="199404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pseudoobscur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457200" y="16765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williston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457200" y="19051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mojaven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457200" y="21337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viril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457200" y="23623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grimshaw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3" name=""/>
          <p:cNvSpPr/>
          <p:nvPr/>
        </p:nvSpPr>
        <p:spPr>
          <a:xfrm>
            <a:off x="457200" y="228600"/>
            <a:ext cx="243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49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04" name="" descr=""/>
          <p:cNvPicPr/>
          <p:nvPr/>
        </p:nvPicPr>
        <p:blipFill>
          <a:blip r:embed="rId1"/>
          <a:stretch/>
        </p:blipFill>
        <p:spPr>
          <a:xfrm>
            <a:off x="1828800" y="380880"/>
            <a:ext cx="7162920" cy="6183360"/>
          </a:xfrm>
          <a:prstGeom prst="rect">
            <a:avLst/>
          </a:prstGeom>
          <a:ln w="0">
            <a:noFill/>
          </a:ln>
        </p:spPr>
      </p:pic>
      <p:grpSp>
        <p:nvGrpSpPr>
          <p:cNvPr id="205" name=""/>
          <p:cNvGrpSpPr/>
          <p:nvPr/>
        </p:nvGrpSpPr>
        <p:grpSpPr>
          <a:xfrm>
            <a:off x="228600" y="990720"/>
            <a:ext cx="2222640" cy="1645560"/>
            <a:chOff x="228600" y="990720"/>
            <a:chExt cx="2222640" cy="1645560"/>
          </a:xfrm>
        </p:grpSpPr>
        <p:sp>
          <p:nvSpPr>
            <p:cNvPr id="206" name=""/>
            <p:cNvSpPr/>
            <p:nvPr/>
          </p:nvSpPr>
          <p:spPr>
            <a:xfrm>
              <a:off x="228600" y="1066680"/>
              <a:ext cx="136440" cy="1368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228600" y="1768320"/>
              <a:ext cx="136440" cy="1368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228600" y="2438280"/>
              <a:ext cx="136440" cy="136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228600" y="1295280"/>
              <a:ext cx="152280" cy="152640"/>
            </a:xfrm>
            <a:prstGeom prst="diamond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228600" y="1981080"/>
              <a:ext cx="152280" cy="152640"/>
            </a:xfrm>
            <a:prstGeom prst="diamond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228600" y="1523880"/>
              <a:ext cx="152280" cy="15264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" bIns="4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 flipV="1">
              <a:off x="228600" y="2209680"/>
              <a:ext cx="152280" cy="15264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" bIns="4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457200" y="9907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melanogaste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457200" y="122868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ananassa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457200" y="1447920"/>
              <a:ext cx="199404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pseudoobscur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457200" y="16765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williston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457200" y="19051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mojaven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457200" y="21337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viril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457200" y="23623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grimshaw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0" name=""/>
          <p:cNvSpPr/>
          <p:nvPr/>
        </p:nvSpPr>
        <p:spPr>
          <a:xfrm>
            <a:off x="457200" y="228600"/>
            <a:ext cx="243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47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1" name="" descr=""/>
          <p:cNvPicPr/>
          <p:nvPr/>
        </p:nvPicPr>
        <p:blipFill>
          <a:blip r:embed="rId1"/>
          <a:stretch/>
        </p:blipFill>
        <p:spPr>
          <a:xfrm>
            <a:off x="2630520" y="228600"/>
            <a:ext cx="5904000" cy="6076800"/>
          </a:xfrm>
          <a:prstGeom prst="rect">
            <a:avLst/>
          </a:prstGeom>
          <a:ln w="0">
            <a:noFill/>
          </a:ln>
        </p:spPr>
      </p:pic>
      <p:grpSp>
        <p:nvGrpSpPr>
          <p:cNvPr id="222" name=""/>
          <p:cNvGrpSpPr/>
          <p:nvPr/>
        </p:nvGrpSpPr>
        <p:grpSpPr>
          <a:xfrm>
            <a:off x="228600" y="990720"/>
            <a:ext cx="2222640" cy="1645560"/>
            <a:chOff x="228600" y="990720"/>
            <a:chExt cx="2222640" cy="1645560"/>
          </a:xfrm>
        </p:grpSpPr>
        <p:sp>
          <p:nvSpPr>
            <p:cNvPr id="223" name=""/>
            <p:cNvSpPr/>
            <p:nvPr/>
          </p:nvSpPr>
          <p:spPr>
            <a:xfrm>
              <a:off x="228600" y="1066680"/>
              <a:ext cx="136440" cy="1368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228600" y="1768320"/>
              <a:ext cx="136440" cy="1368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228600" y="2438280"/>
              <a:ext cx="136440" cy="136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228600" y="1295280"/>
              <a:ext cx="152280" cy="152640"/>
            </a:xfrm>
            <a:prstGeom prst="diamond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228600" y="1981080"/>
              <a:ext cx="152280" cy="152640"/>
            </a:xfrm>
            <a:prstGeom prst="diamond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228600" y="1523880"/>
              <a:ext cx="152280" cy="15264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" bIns="4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 flipV="1">
              <a:off x="228600" y="2209680"/>
              <a:ext cx="152280" cy="15264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" bIns="4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457200" y="9907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melanogaste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457200" y="122868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ananassa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457200" y="1447920"/>
              <a:ext cx="199404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pseudoobscur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457200" y="16765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williston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457200" y="19051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mojaven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457200" y="21337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viril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457200" y="23623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grimshaw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7" name=""/>
          <p:cNvSpPr/>
          <p:nvPr/>
        </p:nvSpPr>
        <p:spPr>
          <a:xfrm>
            <a:off x="457200" y="228600"/>
            <a:ext cx="243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84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38" name="" descr=""/>
          <p:cNvPicPr/>
          <p:nvPr/>
        </p:nvPicPr>
        <p:blipFill>
          <a:blip r:embed="rId1"/>
          <a:stretch/>
        </p:blipFill>
        <p:spPr>
          <a:xfrm>
            <a:off x="1459080" y="152280"/>
            <a:ext cx="7304040" cy="6324840"/>
          </a:xfrm>
          <a:prstGeom prst="rect">
            <a:avLst/>
          </a:prstGeom>
          <a:ln w="0">
            <a:noFill/>
          </a:ln>
        </p:spPr>
      </p:pic>
      <p:grpSp>
        <p:nvGrpSpPr>
          <p:cNvPr id="239" name=""/>
          <p:cNvGrpSpPr/>
          <p:nvPr/>
        </p:nvGrpSpPr>
        <p:grpSpPr>
          <a:xfrm>
            <a:off x="228600" y="4678200"/>
            <a:ext cx="2222640" cy="1645560"/>
            <a:chOff x="228600" y="4678200"/>
            <a:chExt cx="2222640" cy="1645560"/>
          </a:xfrm>
        </p:grpSpPr>
        <p:sp>
          <p:nvSpPr>
            <p:cNvPr id="240" name=""/>
            <p:cNvSpPr/>
            <p:nvPr/>
          </p:nvSpPr>
          <p:spPr>
            <a:xfrm>
              <a:off x="228600" y="4754160"/>
              <a:ext cx="136440" cy="1368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>
              <a:off x="228600" y="5455800"/>
              <a:ext cx="136440" cy="1368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>
              <a:off x="228600" y="6125760"/>
              <a:ext cx="136440" cy="136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>
              <a:off x="228600" y="4982760"/>
              <a:ext cx="152280" cy="152640"/>
            </a:xfrm>
            <a:prstGeom prst="diamond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228600" y="5668560"/>
              <a:ext cx="152280" cy="152640"/>
            </a:xfrm>
            <a:prstGeom prst="diamond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228600" y="5211360"/>
              <a:ext cx="152280" cy="15264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" bIns="4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 flipV="1">
              <a:off x="228600" y="5897160"/>
              <a:ext cx="152280" cy="15264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" bIns="4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457200" y="467820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melanogaste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457200" y="491616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ananassa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457200" y="5135400"/>
              <a:ext cx="199404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pseudoobscur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457200" y="536400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williston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457200" y="559260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mojaven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457200" y="582120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viril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457200" y="604980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grimshaw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4" name=""/>
          <p:cNvSpPr/>
          <p:nvPr/>
        </p:nvSpPr>
        <p:spPr>
          <a:xfrm>
            <a:off x="457200" y="228600"/>
            <a:ext cx="243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30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55" name="" descr=""/>
          <p:cNvPicPr/>
          <p:nvPr/>
        </p:nvPicPr>
        <p:blipFill>
          <a:blip r:embed="rId1"/>
          <a:stretch/>
        </p:blipFill>
        <p:spPr>
          <a:xfrm>
            <a:off x="2133720" y="1219320"/>
            <a:ext cx="5000400" cy="3655800"/>
          </a:xfrm>
          <a:prstGeom prst="rect">
            <a:avLst/>
          </a:prstGeom>
          <a:ln w="0">
            <a:noFill/>
          </a:ln>
        </p:spPr>
      </p:pic>
      <p:grpSp>
        <p:nvGrpSpPr>
          <p:cNvPr id="256" name=""/>
          <p:cNvGrpSpPr/>
          <p:nvPr/>
        </p:nvGrpSpPr>
        <p:grpSpPr>
          <a:xfrm>
            <a:off x="228600" y="4678200"/>
            <a:ext cx="2222640" cy="1645560"/>
            <a:chOff x="228600" y="4678200"/>
            <a:chExt cx="2222640" cy="1645560"/>
          </a:xfrm>
        </p:grpSpPr>
        <p:sp>
          <p:nvSpPr>
            <p:cNvPr id="257" name=""/>
            <p:cNvSpPr/>
            <p:nvPr/>
          </p:nvSpPr>
          <p:spPr>
            <a:xfrm>
              <a:off x="228600" y="4754160"/>
              <a:ext cx="136440" cy="1368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228600" y="5455800"/>
              <a:ext cx="136440" cy="1368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228600" y="6125760"/>
              <a:ext cx="136440" cy="136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228600" y="4982760"/>
              <a:ext cx="152280" cy="152640"/>
            </a:xfrm>
            <a:prstGeom prst="diamond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228600" y="5668560"/>
              <a:ext cx="152280" cy="152640"/>
            </a:xfrm>
            <a:prstGeom prst="diamond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228600" y="5211360"/>
              <a:ext cx="152280" cy="15264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" bIns="4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 flipV="1">
              <a:off x="228600" y="5897160"/>
              <a:ext cx="152280" cy="15264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" bIns="4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457200" y="467820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melanogaste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457200" y="491616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ananassa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457200" y="5135400"/>
              <a:ext cx="199404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pseudoobscur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457200" y="536400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williston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457200" y="559260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mojaven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457200" y="582120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viril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457200" y="604980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grimshaw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"/>
          <p:cNvSpPr/>
          <p:nvPr/>
        </p:nvSpPr>
        <p:spPr>
          <a:xfrm>
            <a:off x="457200" y="228600"/>
            <a:ext cx="243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67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" name="" descr=""/>
          <p:cNvPicPr/>
          <p:nvPr/>
        </p:nvPicPr>
        <p:blipFill>
          <a:blip r:embed="rId1"/>
          <a:stretch/>
        </p:blipFill>
        <p:spPr>
          <a:xfrm>
            <a:off x="3352680" y="1143000"/>
            <a:ext cx="4599000" cy="3960720"/>
          </a:xfrm>
          <a:prstGeom prst="rect">
            <a:avLst/>
          </a:prstGeom>
          <a:ln w="0">
            <a:noFill/>
          </a:ln>
        </p:spPr>
      </p:pic>
      <p:grpSp>
        <p:nvGrpSpPr>
          <p:cNvPr id="68" name=""/>
          <p:cNvGrpSpPr/>
          <p:nvPr/>
        </p:nvGrpSpPr>
        <p:grpSpPr>
          <a:xfrm>
            <a:off x="228600" y="990720"/>
            <a:ext cx="2222640" cy="1645560"/>
            <a:chOff x="228600" y="990720"/>
            <a:chExt cx="2222640" cy="1645560"/>
          </a:xfrm>
        </p:grpSpPr>
        <p:sp>
          <p:nvSpPr>
            <p:cNvPr id="69" name=""/>
            <p:cNvSpPr/>
            <p:nvPr/>
          </p:nvSpPr>
          <p:spPr>
            <a:xfrm>
              <a:off x="228600" y="1066680"/>
              <a:ext cx="136440" cy="1368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228600" y="1768320"/>
              <a:ext cx="136440" cy="1368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228600" y="2438280"/>
              <a:ext cx="136440" cy="136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228600" y="1295280"/>
              <a:ext cx="152280" cy="152640"/>
            </a:xfrm>
            <a:prstGeom prst="diamond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228600" y="1981080"/>
              <a:ext cx="152280" cy="152640"/>
            </a:xfrm>
            <a:prstGeom prst="diamond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228600" y="1523880"/>
              <a:ext cx="152280" cy="15264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" bIns="4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 flipV="1">
              <a:off x="228600" y="2209680"/>
              <a:ext cx="152280" cy="15264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" bIns="4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457200" y="9907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melanogaste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457200" y="122868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ananassa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457200" y="1447920"/>
              <a:ext cx="199404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pseudoobscur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457200" y="16765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williston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457200" y="19051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mojaven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457200" y="21337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viril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457200" y="23623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grimshaw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"/>
          <p:cNvSpPr/>
          <p:nvPr/>
        </p:nvSpPr>
        <p:spPr>
          <a:xfrm>
            <a:off x="457200" y="228600"/>
            <a:ext cx="243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78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4" name="" descr=""/>
          <p:cNvPicPr/>
          <p:nvPr/>
        </p:nvPicPr>
        <p:blipFill>
          <a:blip r:embed="rId1"/>
          <a:stretch/>
        </p:blipFill>
        <p:spPr>
          <a:xfrm>
            <a:off x="2563920" y="657360"/>
            <a:ext cx="4016160" cy="5543280"/>
          </a:xfrm>
          <a:prstGeom prst="rect">
            <a:avLst/>
          </a:prstGeom>
          <a:ln w="0">
            <a:noFill/>
          </a:ln>
        </p:spPr>
      </p:pic>
      <p:grpSp>
        <p:nvGrpSpPr>
          <p:cNvPr id="85" name=""/>
          <p:cNvGrpSpPr/>
          <p:nvPr/>
        </p:nvGrpSpPr>
        <p:grpSpPr>
          <a:xfrm>
            <a:off x="228600" y="990720"/>
            <a:ext cx="2222640" cy="1645560"/>
            <a:chOff x="228600" y="990720"/>
            <a:chExt cx="2222640" cy="1645560"/>
          </a:xfrm>
        </p:grpSpPr>
        <p:sp>
          <p:nvSpPr>
            <p:cNvPr id="86" name=""/>
            <p:cNvSpPr/>
            <p:nvPr/>
          </p:nvSpPr>
          <p:spPr>
            <a:xfrm>
              <a:off x="228600" y="1066680"/>
              <a:ext cx="136440" cy="1368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228600" y="1768320"/>
              <a:ext cx="136440" cy="1368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228600" y="2438280"/>
              <a:ext cx="136440" cy="136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228600" y="1295280"/>
              <a:ext cx="152280" cy="152640"/>
            </a:xfrm>
            <a:prstGeom prst="diamond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228600" y="1981080"/>
              <a:ext cx="152280" cy="152640"/>
            </a:xfrm>
            <a:prstGeom prst="diamond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228600" y="1523880"/>
              <a:ext cx="152280" cy="15264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" bIns="4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 flipV="1">
              <a:off x="228600" y="2209680"/>
              <a:ext cx="152280" cy="15264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" bIns="4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457200" y="9907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melanogaste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457200" y="122868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ananassa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457200" y="1447920"/>
              <a:ext cx="199404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pseudoobscur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457200" y="16765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williston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457200" y="19051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mojaven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457200" y="21337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viril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457200" y="23623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grimshaw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"/>
          <p:cNvSpPr/>
          <p:nvPr/>
        </p:nvSpPr>
        <p:spPr>
          <a:xfrm>
            <a:off x="2819520" y="6324480"/>
            <a:ext cx="335268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457200" y="228600"/>
            <a:ext cx="243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76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2" name="" descr=""/>
          <p:cNvPicPr/>
          <p:nvPr/>
        </p:nvPicPr>
        <p:blipFill>
          <a:blip r:embed="rId1"/>
          <a:stretch/>
        </p:blipFill>
        <p:spPr>
          <a:xfrm>
            <a:off x="2568600" y="744480"/>
            <a:ext cx="4006800" cy="5370480"/>
          </a:xfrm>
          <a:prstGeom prst="rect">
            <a:avLst/>
          </a:prstGeom>
          <a:ln w="0">
            <a:noFill/>
          </a:ln>
        </p:spPr>
      </p:pic>
      <p:grpSp>
        <p:nvGrpSpPr>
          <p:cNvPr id="103" name=""/>
          <p:cNvGrpSpPr/>
          <p:nvPr/>
        </p:nvGrpSpPr>
        <p:grpSpPr>
          <a:xfrm>
            <a:off x="228600" y="990720"/>
            <a:ext cx="2222640" cy="1645560"/>
            <a:chOff x="228600" y="990720"/>
            <a:chExt cx="2222640" cy="1645560"/>
          </a:xfrm>
        </p:grpSpPr>
        <p:sp>
          <p:nvSpPr>
            <p:cNvPr id="104" name=""/>
            <p:cNvSpPr/>
            <p:nvPr/>
          </p:nvSpPr>
          <p:spPr>
            <a:xfrm>
              <a:off x="228600" y="1066680"/>
              <a:ext cx="136440" cy="1368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228600" y="1768320"/>
              <a:ext cx="136440" cy="1368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228600" y="2438280"/>
              <a:ext cx="136440" cy="136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228600" y="1295280"/>
              <a:ext cx="152280" cy="152640"/>
            </a:xfrm>
            <a:prstGeom prst="diamond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228600" y="1981080"/>
              <a:ext cx="152280" cy="152640"/>
            </a:xfrm>
            <a:prstGeom prst="diamond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228600" y="1523880"/>
              <a:ext cx="152280" cy="15264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" bIns="4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 flipV="1">
              <a:off x="228600" y="2209680"/>
              <a:ext cx="152280" cy="15264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" bIns="4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457200" y="9907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melanogaste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457200" y="122868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ananassa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457200" y="1447920"/>
              <a:ext cx="199404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pseudoobscur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457200" y="16765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williston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457200" y="19051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mojaven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457200" y="21337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viril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457200" y="23623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grimshaw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"/>
          <p:cNvSpPr/>
          <p:nvPr/>
        </p:nvSpPr>
        <p:spPr>
          <a:xfrm>
            <a:off x="457200" y="228600"/>
            <a:ext cx="243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72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9" name="" descr=""/>
          <p:cNvPicPr/>
          <p:nvPr/>
        </p:nvPicPr>
        <p:blipFill>
          <a:blip r:embed="rId1"/>
          <a:stretch/>
        </p:blipFill>
        <p:spPr>
          <a:xfrm>
            <a:off x="2568600" y="1352520"/>
            <a:ext cx="4006800" cy="4152960"/>
          </a:xfrm>
          <a:prstGeom prst="rect">
            <a:avLst/>
          </a:prstGeom>
          <a:ln w="0">
            <a:noFill/>
          </a:ln>
        </p:spPr>
      </p:pic>
      <p:grpSp>
        <p:nvGrpSpPr>
          <p:cNvPr id="120" name=""/>
          <p:cNvGrpSpPr/>
          <p:nvPr/>
        </p:nvGrpSpPr>
        <p:grpSpPr>
          <a:xfrm>
            <a:off x="228600" y="990720"/>
            <a:ext cx="2222640" cy="1645560"/>
            <a:chOff x="228600" y="990720"/>
            <a:chExt cx="2222640" cy="1645560"/>
          </a:xfrm>
        </p:grpSpPr>
        <p:sp>
          <p:nvSpPr>
            <p:cNvPr id="121" name=""/>
            <p:cNvSpPr/>
            <p:nvPr/>
          </p:nvSpPr>
          <p:spPr>
            <a:xfrm>
              <a:off x="228600" y="1066680"/>
              <a:ext cx="136440" cy="1368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228600" y="1768320"/>
              <a:ext cx="136440" cy="1368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228600" y="2438280"/>
              <a:ext cx="136440" cy="136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228600" y="1295280"/>
              <a:ext cx="152280" cy="152640"/>
            </a:xfrm>
            <a:prstGeom prst="diamond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228600" y="1981080"/>
              <a:ext cx="152280" cy="152640"/>
            </a:xfrm>
            <a:prstGeom prst="diamond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228600" y="1523880"/>
              <a:ext cx="152280" cy="15264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" bIns="4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 flipV="1">
              <a:off x="228600" y="2209680"/>
              <a:ext cx="152280" cy="15264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" bIns="4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457200" y="9907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melanogaste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457200" y="122868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ananassa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457200" y="1447920"/>
              <a:ext cx="199404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pseudoobscur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457200" y="16765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williston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457200" y="19051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mojaven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457200" y="21337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viril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457200" y="23623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grimshaw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"/>
          <p:cNvSpPr/>
          <p:nvPr/>
        </p:nvSpPr>
        <p:spPr>
          <a:xfrm>
            <a:off x="457200" y="228600"/>
            <a:ext cx="243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66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6" name="" descr=""/>
          <p:cNvPicPr/>
          <p:nvPr/>
        </p:nvPicPr>
        <p:blipFill>
          <a:blip r:embed="rId1"/>
          <a:stretch/>
        </p:blipFill>
        <p:spPr>
          <a:xfrm>
            <a:off x="2563920" y="1352520"/>
            <a:ext cx="4016160" cy="4152960"/>
          </a:xfrm>
          <a:prstGeom prst="rect">
            <a:avLst/>
          </a:prstGeom>
          <a:ln w="0">
            <a:noFill/>
          </a:ln>
        </p:spPr>
      </p:pic>
      <p:grpSp>
        <p:nvGrpSpPr>
          <p:cNvPr id="137" name=""/>
          <p:cNvGrpSpPr/>
          <p:nvPr/>
        </p:nvGrpSpPr>
        <p:grpSpPr>
          <a:xfrm>
            <a:off x="228600" y="990720"/>
            <a:ext cx="2222640" cy="1645560"/>
            <a:chOff x="228600" y="990720"/>
            <a:chExt cx="2222640" cy="1645560"/>
          </a:xfrm>
        </p:grpSpPr>
        <p:sp>
          <p:nvSpPr>
            <p:cNvPr id="138" name=""/>
            <p:cNvSpPr/>
            <p:nvPr/>
          </p:nvSpPr>
          <p:spPr>
            <a:xfrm>
              <a:off x="228600" y="1066680"/>
              <a:ext cx="136440" cy="1368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228600" y="1768320"/>
              <a:ext cx="136440" cy="1368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228600" y="2438280"/>
              <a:ext cx="136440" cy="136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228600" y="1295280"/>
              <a:ext cx="152280" cy="152640"/>
            </a:xfrm>
            <a:prstGeom prst="diamond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228600" y="1981080"/>
              <a:ext cx="152280" cy="152640"/>
            </a:xfrm>
            <a:prstGeom prst="diamond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228600" y="1523880"/>
              <a:ext cx="152280" cy="15264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" bIns="4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 flipV="1">
              <a:off x="228600" y="2209680"/>
              <a:ext cx="152280" cy="15264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" bIns="4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457200" y="9907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melanogaste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457200" y="122868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ananassa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457200" y="1447920"/>
              <a:ext cx="199404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pseudoobscur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457200" y="16765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williston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457200" y="19051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mojaven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457200" y="21337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viril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457200" y="23623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grimshaw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"/>
          <p:cNvSpPr/>
          <p:nvPr/>
        </p:nvSpPr>
        <p:spPr>
          <a:xfrm>
            <a:off x="457200" y="228600"/>
            <a:ext cx="243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65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3" name=""/>
          <p:cNvGrpSpPr/>
          <p:nvPr/>
        </p:nvGrpSpPr>
        <p:grpSpPr>
          <a:xfrm>
            <a:off x="228600" y="990720"/>
            <a:ext cx="2222640" cy="1645560"/>
            <a:chOff x="228600" y="990720"/>
            <a:chExt cx="2222640" cy="1645560"/>
          </a:xfrm>
        </p:grpSpPr>
        <p:sp>
          <p:nvSpPr>
            <p:cNvPr id="154" name=""/>
            <p:cNvSpPr/>
            <p:nvPr/>
          </p:nvSpPr>
          <p:spPr>
            <a:xfrm>
              <a:off x="228600" y="1066680"/>
              <a:ext cx="136440" cy="1368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228600" y="1768320"/>
              <a:ext cx="136440" cy="1368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228600" y="2438280"/>
              <a:ext cx="136440" cy="136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228600" y="1295280"/>
              <a:ext cx="152280" cy="152640"/>
            </a:xfrm>
            <a:prstGeom prst="diamond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228600" y="1981080"/>
              <a:ext cx="152280" cy="152640"/>
            </a:xfrm>
            <a:prstGeom prst="diamond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228600" y="1523880"/>
              <a:ext cx="152280" cy="15264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" bIns="4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 flipV="1">
              <a:off x="228600" y="2209680"/>
              <a:ext cx="152280" cy="15264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" bIns="4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457200" y="9907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melanogaste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457200" y="122868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ananassa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457200" y="1447920"/>
              <a:ext cx="199404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pseudoobscur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457200" y="16765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williston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457200" y="19051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mojaven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457200" y="21337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viril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457200" y="23623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grimshaw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168" name="" descr=""/>
          <p:cNvPicPr/>
          <p:nvPr/>
        </p:nvPicPr>
        <p:blipFill>
          <a:blip r:embed="rId1"/>
          <a:stretch/>
        </p:blipFill>
        <p:spPr>
          <a:xfrm>
            <a:off x="2514600" y="990720"/>
            <a:ext cx="4241880" cy="4570200"/>
          </a:xfrm>
          <a:prstGeom prst="rect">
            <a:avLst/>
          </a:prstGeom>
          <a:ln w="0">
            <a:noFill/>
          </a:ln>
        </p:spPr>
      </p:pic>
    </p:spTree>
  </p:cSld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"/>
          <p:cNvSpPr/>
          <p:nvPr/>
        </p:nvSpPr>
        <p:spPr>
          <a:xfrm>
            <a:off x="457200" y="228600"/>
            <a:ext cx="243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64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0" name="" descr=""/>
          <p:cNvPicPr/>
          <p:nvPr/>
        </p:nvPicPr>
        <p:blipFill>
          <a:blip r:embed="rId1"/>
          <a:stretch/>
        </p:blipFill>
        <p:spPr>
          <a:xfrm>
            <a:off x="2568600" y="744480"/>
            <a:ext cx="4006800" cy="5370480"/>
          </a:xfrm>
          <a:prstGeom prst="rect">
            <a:avLst/>
          </a:prstGeom>
          <a:ln w="0">
            <a:noFill/>
          </a:ln>
        </p:spPr>
      </p:pic>
      <p:grpSp>
        <p:nvGrpSpPr>
          <p:cNvPr id="171" name=""/>
          <p:cNvGrpSpPr/>
          <p:nvPr/>
        </p:nvGrpSpPr>
        <p:grpSpPr>
          <a:xfrm>
            <a:off x="228600" y="990720"/>
            <a:ext cx="2222640" cy="1645560"/>
            <a:chOff x="228600" y="990720"/>
            <a:chExt cx="2222640" cy="1645560"/>
          </a:xfrm>
        </p:grpSpPr>
        <p:sp>
          <p:nvSpPr>
            <p:cNvPr id="172" name=""/>
            <p:cNvSpPr/>
            <p:nvPr/>
          </p:nvSpPr>
          <p:spPr>
            <a:xfrm>
              <a:off x="228600" y="1066680"/>
              <a:ext cx="136440" cy="1368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228600" y="1768320"/>
              <a:ext cx="136440" cy="1368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228600" y="2438280"/>
              <a:ext cx="136440" cy="136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228600" y="1295280"/>
              <a:ext cx="152280" cy="152640"/>
            </a:xfrm>
            <a:prstGeom prst="diamond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228600" y="1981080"/>
              <a:ext cx="152280" cy="152640"/>
            </a:xfrm>
            <a:prstGeom prst="diamond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228600" y="1523880"/>
              <a:ext cx="152280" cy="15264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" bIns="4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 flipV="1">
              <a:off x="228600" y="2209680"/>
              <a:ext cx="152280" cy="15264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" bIns="4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457200" y="9907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melanogaste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457200" y="122868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ananassa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457200" y="1447920"/>
              <a:ext cx="199404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pseudoobscur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457200" y="16765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williston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457200" y="19051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mojaven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457200" y="21337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viril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457200" y="23623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grimshaw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"/>
          <p:cNvSpPr/>
          <p:nvPr/>
        </p:nvSpPr>
        <p:spPr>
          <a:xfrm>
            <a:off x="457200" y="228600"/>
            <a:ext cx="243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62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7" name="" descr=""/>
          <p:cNvPicPr/>
          <p:nvPr/>
        </p:nvPicPr>
        <p:blipFill>
          <a:blip r:embed="rId1"/>
          <a:stretch/>
        </p:blipFill>
        <p:spPr>
          <a:xfrm>
            <a:off x="2568600" y="1525680"/>
            <a:ext cx="4006800" cy="3806640"/>
          </a:xfrm>
          <a:prstGeom prst="rect">
            <a:avLst/>
          </a:prstGeom>
          <a:ln w="0">
            <a:noFill/>
          </a:ln>
        </p:spPr>
      </p:pic>
      <p:grpSp>
        <p:nvGrpSpPr>
          <p:cNvPr id="188" name=""/>
          <p:cNvGrpSpPr/>
          <p:nvPr/>
        </p:nvGrpSpPr>
        <p:grpSpPr>
          <a:xfrm>
            <a:off x="228600" y="990720"/>
            <a:ext cx="2222640" cy="1645560"/>
            <a:chOff x="228600" y="990720"/>
            <a:chExt cx="2222640" cy="1645560"/>
          </a:xfrm>
        </p:grpSpPr>
        <p:sp>
          <p:nvSpPr>
            <p:cNvPr id="189" name=""/>
            <p:cNvSpPr/>
            <p:nvPr/>
          </p:nvSpPr>
          <p:spPr>
            <a:xfrm>
              <a:off x="228600" y="1066680"/>
              <a:ext cx="136440" cy="1368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228600" y="1768320"/>
              <a:ext cx="136440" cy="1368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228600" y="2438280"/>
              <a:ext cx="136440" cy="136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228600" y="1295280"/>
              <a:ext cx="152280" cy="152640"/>
            </a:xfrm>
            <a:prstGeom prst="diamond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228600" y="1981080"/>
              <a:ext cx="152280" cy="152640"/>
            </a:xfrm>
            <a:prstGeom prst="diamond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228600" y="1523880"/>
              <a:ext cx="152280" cy="15264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" bIns="4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 flipV="1">
              <a:off x="228600" y="2209680"/>
              <a:ext cx="152280" cy="15264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" bIns="4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457200" y="9907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melanogaste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457200" y="122868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ananassa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457200" y="1447920"/>
              <a:ext cx="199404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pseudoobscur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457200" y="16765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williston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457200" y="19051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mojaven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457200" y="21337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viril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>
              <a:off x="457200" y="2362320"/>
              <a:ext cx="1828800" cy="27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240" bIns="46800" anchor="t">
              <a:spAutoFit/>
            </a:bodyPr>
            <a:p>
              <a:pPr>
                <a:lnSpc>
                  <a:spcPct val="93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D. grimshaw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0-31T21:24:50Z</dcterms:created>
  <dc:creator>Willis Lab Workstation</dc:creator>
  <dc:description/>
  <dc:language>en-US</dc:language>
  <cp:lastModifiedBy>Anita M. Collins</cp:lastModifiedBy>
  <dcterms:modified xsi:type="dcterms:W3CDTF">2009-11-16T17:28:41Z</dcterms:modified>
  <cp:revision>14</cp:revision>
  <dc:subject/>
  <dc:title>Slide 1</dc:title>
</cp:coreProperties>
</file>